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>
        <p:scale>
          <a:sx n="333" d="100"/>
          <a:sy n="333" d="100"/>
        </p:scale>
        <p:origin x="-6216" y="-85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581B3B-D0F6-41AE-812C-9B868C22F48A}" type="datetimeFigureOut">
              <a:rPr lang="en-US" smtClean="0"/>
              <a:pPr/>
              <a:t>10/2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CAB6D3-AB26-4552-AD4E-4140490A6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67DC5B0-D46D-BB4C-A9C7-760FEAA51E29}"/>
              </a:ext>
            </a:extLst>
          </p:cNvPr>
          <p:cNvSpPr txBox="1"/>
          <p:nvPr/>
        </p:nvSpPr>
        <p:spPr>
          <a:xfrm>
            <a:off x="0" y="5380672"/>
            <a:ext cx="914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S1 The GC-MS measurements for the allantoin (</a:t>
            </a:r>
            <a:r>
              <a:rPr lang="en-US" dirty="0" err="1"/>
              <a:t>Allt</a:t>
            </a:r>
            <a:r>
              <a:rPr lang="en-US" dirty="0"/>
              <a:t>), A. The chromatogram for allantoin based on the peak for the standard compound M/z 331, red and blue different concentrations for </a:t>
            </a:r>
            <a:r>
              <a:rPr lang="en-US" dirty="0" err="1"/>
              <a:t>Allt</a:t>
            </a:r>
            <a:r>
              <a:rPr lang="en-US" dirty="0"/>
              <a:t>. B. The mass spectrum for standard allantoin at retention time 8.05 min C. The mass spectrum for cell extracted allantoin at retention time 8.05 min. </a:t>
            </a:r>
          </a:p>
        </p:txBody>
      </p:sp>
      <p:pic>
        <p:nvPicPr>
          <p:cNvPr id="6" name="Picture 3">
            <a:extLst>
              <a:ext uri="{FF2B5EF4-FFF2-40B4-BE49-F238E27FC236}">
                <a16:creationId xmlns:a16="http://schemas.microsoft.com/office/drawing/2014/main" id="{0B2A1B92-7F08-7C45-83C6-07918F5A45D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10123" y="533399"/>
            <a:ext cx="7065860" cy="1787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2">
            <a:extLst>
              <a:ext uri="{FF2B5EF4-FFF2-40B4-BE49-F238E27FC236}">
                <a16:creationId xmlns:a16="http://schemas.microsoft.com/office/drawing/2014/main" id="{9748F646-941E-8F41-967F-8D864A8BDAB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17037" y="3921291"/>
            <a:ext cx="6031563" cy="13834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6">
            <a:extLst>
              <a:ext uri="{FF2B5EF4-FFF2-40B4-BE49-F238E27FC236}">
                <a16:creationId xmlns:a16="http://schemas.microsoft.com/office/drawing/2014/main" id="{15765247-B0BE-5B46-B1FB-A7F40F56C33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38959" y="2397291"/>
            <a:ext cx="70104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7DB8901-1439-A14F-86AA-152E9257F295}"/>
              </a:ext>
            </a:extLst>
          </p:cNvPr>
          <p:cNvSpPr txBox="1"/>
          <p:nvPr/>
        </p:nvSpPr>
        <p:spPr>
          <a:xfrm>
            <a:off x="451491" y="533399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2428A47-66EC-BC43-A6B0-0E60F1FD6068}"/>
              </a:ext>
            </a:extLst>
          </p:cNvPr>
          <p:cNvSpPr txBox="1"/>
          <p:nvPr/>
        </p:nvSpPr>
        <p:spPr>
          <a:xfrm>
            <a:off x="355397" y="2120292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D1F68A7-4EF0-5C4D-9FEE-68C8C6944909}"/>
              </a:ext>
            </a:extLst>
          </p:cNvPr>
          <p:cNvSpPr txBox="1"/>
          <p:nvPr/>
        </p:nvSpPr>
        <p:spPr>
          <a:xfrm>
            <a:off x="359850" y="4144770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pic>
        <p:nvPicPr>
          <p:cNvPr id="1026" name="Picture 2" descr="Allantoin | ≥99%(HPLC) | Selleck | Others chemical">
            <a:extLst>
              <a:ext uri="{FF2B5EF4-FFF2-40B4-BE49-F238E27FC236}">
                <a16:creationId xmlns:a16="http://schemas.microsoft.com/office/drawing/2014/main" id="{A4B8AC13-8B16-8002-3F4B-550C54387B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29400" y="728453"/>
            <a:ext cx="1024759" cy="6831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64497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</TotalTime>
  <Words>73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Ivan D Rodionov</cp:lastModifiedBy>
  <cp:revision>14</cp:revision>
  <dcterms:created xsi:type="dcterms:W3CDTF">2020-04-15T21:23:16Z</dcterms:created>
  <dcterms:modified xsi:type="dcterms:W3CDTF">2022-10-25T18:01:35Z</dcterms:modified>
</cp:coreProperties>
</file>